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38" autoAdjust="0"/>
    <p:restoredTop sz="94660"/>
  </p:normalViewPr>
  <p:slideViewPr>
    <p:cSldViewPr snapToGrid="0" showGuides="1">
      <p:cViewPr varScale="1">
        <p:scale>
          <a:sx n="58" d="100"/>
          <a:sy n="58" d="100"/>
        </p:scale>
        <p:origin x="1964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944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013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07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0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23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547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1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84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07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779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70928-0581-487C-BF01-AD815A7EA6AA}" type="datetimeFigureOut">
              <a:rPr lang="en-US" smtClean="0"/>
              <a:t>2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371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70802" y="173736"/>
            <a:ext cx="6858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7 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Quality scores of </a:t>
            </a:r>
            <a:r>
              <a:rPr lang="en-US" sz="1000" b="1" dirty="0" err="1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astq</a:t>
            </a: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eads for the input and </a:t>
            </a:r>
            <a:r>
              <a:rPr lang="en-US" sz="1000" b="1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hIP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DNA </a:t>
            </a: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amples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0" y="781038"/>
            <a:ext cx="6904299" cy="2644904"/>
            <a:chOff x="0" y="707886"/>
            <a:chExt cx="6904299" cy="2644904"/>
          </a:xfrm>
        </p:grpSpPr>
        <p:sp>
          <p:nvSpPr>
            <p:cNvPr id="6" name="TextBox 5"/>
            <p:cNvSpPr txBox="1"/>
            <p:nvPr/>
          </p:nvSpPr>
          <p:spPr>
            <a:xfrm>
              <a:off x="0" y="707886"/>
              <a:ext cx="46761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Quality scores for input DNA from replicate 1.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541"/>
            <a:stretch/>
          </p:blipFill>
          <p:spPr>
            <a:xfrm>
              <a:off x="46299" y="923544"/>
              <a:ext cx="6858000" cy="2429246"/>
            </a:xfrm>
            <a:prstGeom prst="rect">
              <a:avLst/>
            </a:prstGeom>
          </p:spPr>
        </p:pic>
      </p:grpSp>
      <p:grpSp>
        <p:nvGrpSpPr>
          <p:cNvPr id="10" name="Group 9"/>
          <p:cNvGrpSpPr/>
          <p:nvPr/>
        </p:nvGrpSpPr>
        <p:grpSpPr>
          <a:xfrm>
            <a:off x="0" y="3617802"/>
            <a:ext cx="6858000" cy="2748084"/>
            <a:chOff x="0" y="3928698"/>
            <a:chExt cx="6858000" cy="2748084"/>
          </a:xfrm>
        </p:grpSpPr>
        <p:sp>
          <p:nvSpPr>
            <p:cNvPr id="16" name="TextBox 15"/>
            <p:cNvSpPr txBox="1"/>
            <p:nvPr/>
          </p:nvSpPr>
          <p:spPr>
            <a:xfrm>
              <a:off x="70802" y="3928698"/>
              <a:ext cx="49309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Quality scores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or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I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NA from replicate 1.</a:t>
              </a: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45"/>
            <a:stretch/>
          </p:blipFill>
          <p:spPr>
            <a:xfrm>
              <a:off x="0" y="4229619"/>
              <a:ext cx="6858000" cy="244716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8629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323838"/>
            <a:ext cx="46761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Quality scores for input DNA from replicate 2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0802" y="3617802"/>
            <a:ext cx="49309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Quality score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NA from replicat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" t="4500"/>
          <a:stretch/>
        </p:blipFill>
        <p:spPr>
          <a:xfrm>
            <a:off x="18288" y="685799"/>
            <a:ext cx="6839712" cy="245600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" t="4418"/>
          <a:stretch/>
        </p:blipFill>
        <p:spPr>
          <a:xfrm>
            <a:off x="18288" y="3977639"/>
            <a:ext cx="6848856" cy="2458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5735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6</TotalTime>
  <Words>64</Words>
  <Application>Microsoft Office PowerPoint</Application>
  <PresentationFormat>On-screen Show (4:3)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gxia</dc:creator>
  <cp:lastModifiedBy>Dingxia</cp:lastModifiedBy>
  <cp:revision>34</cp:revision>
  <cp:lastPrinted>2023-01-23T06:24:09Z</cp:lastPrinted>
  <dcterms:created xsi:type="dcterms:W3CDTF">2023-01-23T06:15:50Z</dcterms:created>
  <dcterms:modified xsi:type="dcterms:W3CDTF">2023-02-02T14:57:23Z</dcterms:modified>
</cp:coreProperties>
</file>